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9" r:id="rId2"/>
    <p:sldId id="265" r:id="rId3"/>
    <p:sldId id="267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51" autoAdjust="0"/>
    <p:restoredTop sz="94660"/>
  </p:normalViewPr>
  <p:slideViewPr>
    <p:cSldViewPr snapToGrid="0">
      <p:cViewPr>
        <p:scale>
          <a:sx n="87" d="100"/>
          <a:sy n="87" d="100"/>
        </p:scale>
        <p:origin x="3036" y="3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7E2DD-3ECF-481A-8191-9CD8D50450E1}" type="datetimeFigureOut">
              <a:rPr lang="ko-KR" altLang="en-US" smtClean="0"/>
              <a:t>2020-09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3153C-BDB6-4BB8-8026-E50DFFEBDF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582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7E2DD-3ECF-481A-8191-9CD8D50450E1}" type="datetimeFigureOut">
              <a:rPr lang="ko-KR" altLang="en-US" smtClean="0"/>
              <a:t>2020-09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3153C-BDB6-4BB8-8026-E50DFFEBDF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4338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7E2DD-3ECF-481A-8191-9CD8D50450E1}" type="datetimeFigureOut">
              <a:rPr lang="ko-KR" altLang="en-US" smtClean="0"/>
              <a:t>2020-09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3153C-BDB6-4BB8-8026-E50DFFEBDF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0868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7E2DD-3ECF-481A-8191-9CD8D50450E1}" type="datetimeFigureOut">
              <a:rPr lang="ko-KR" altLang="en-US" smtClean="0"/>
              <a:t>2020-09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3153C-BDB6-4BB8-8026-E50DFFEBDF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646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7E2DD-3ECF-481A-8191-9CD8D50450E1}" type="datetimeFigureOut">
              <a:rPr lang="ko-KR" altLang="en-US" smtClean="0"/>
              <a:t>2020-09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3153C-BDB6-4BB8-8026-E50DFFEBDF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2932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7E2DD-3ECF-481A-8191-9CD8D50450E1}" type="datetimeFigureOut">
              <a:rPr lang="ko-KR" altLang="en-US" smtClean="0"/>
              <a:t>2020-09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3153C-BDB6-4BB8-8026-E50DFFEBDF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6218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7E2DD-3ECF-481A-8191-9CD8D50450E1}" type="datetimeFigureOut">
              <a:rPr lang="ko-KR" altLang="en-US" smtClean="0"/>
              <a:t>2020-09-2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3153C-BDB6-4BB8-8026-E50DFFEBDF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876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7E2DD-3ECF-481A-8191-9CD8D50450E1}" type="datetimeFigureOut">
              <a:rPr lang="ko-KR" altLang="en-US" smtClean="0"/>
              <a:t>2020-09-2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3153C-BDB6-4BB8-8026-E50DFFEBDF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0860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7E2DD-3ECF-481A-8191-9CD8D50450E1}" type="datetimeFigureOut">
              <a:rPr lang="ko-KR" altLang="en-US" smtClean="0"/>
              <a:t>2020-09-2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3153C-BDB6-4BB8-8026-E50DFFEBDF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9646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7E2DD-3ECF-481A-8191-9CD8D50450E1}" type="datetimeFigureOut">
              <a:rPr lang="ko-KR" altLang="en-US" smtClean="0"/>
              <a:t>2020-09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3153C-BDB6-4BB8-8026-E50DFFEBDF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6724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7E2DD-3ECF-481A-8191-9CD8D50450E1}" type="datetimeFigureOut">
              <a:rPr lang="ko-KR" altLang="en-US" smtClean="0"/>
              <a:t>2020-09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3153C-BDB6-4BB8-8026-E50DFFEBDF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5220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A7E2DD-3ECF-481A-8191-9CD8D50450E1}" type="datetimeFigureOut">
              <a:rPr lang="ko-KR" altLang="en-US" smtClean="0"/>
              <a:t>2020-09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23153C-BDB6-4BB8-8026-E50DFFEBDFE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3092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g"/><Relationship Id="rId3" Type="http://schemas.openxmlformats.org/officeDocument/2006/relationships/image" Target="../media/image9.jpeg"/><Relationship Id="rId7" Type="http://schemas.openxmlformats.org/officeDocument/2006/relationships/image" Target="../media/image13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jpeg"/><Relationship Id="rId5" Type="http://schemas.openxmlformats.org/officeDocument/2006/relationships/image" Target="../media/image11.jpeg"/><Relationship Id="rId4" Type="http://schemas.openxmlformats.org/officeDocument/2006/relationships/image" Target="../media/image10.jpeg"/><Relationship Id="rId9" Type="http://schemas.openxmlformats.org/officeDocument/2006/relationships/image" Target="../media/image15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" y="0"/>
            <a:ext cx="67558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 1. 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-1232" y="929620"/>
            <a:ext cx="2720368" cy="1840311"/>
            <a:chOff x="1148976" y="5210783"/>
            <a:chExt cx="2720368" cy="1840311"/>
          </a:xfrm>
        </p:grpSpPr>
        <p:grpSp>
          <p:nvGrpSpPr>
            <p:cNvPr id="41" name="그룹 40"/>
            <p:cNvGrpSpPr/>
            <p:nvPr/>
          </p:nvGrpSpPr>
          <p:grpSpPr>
            <a:xfrm>
              <a:off x="1148976" y="5210783"/>
              <a:ext cx="2720368" cy="1840311"/>
              <a:chOff x="49964" y="3261333"/>
              <a:chExt cx="2720368" cy="1840311"/>
            </a:xfrm>
          </p:grpSpPr>
          <p:sp>
            <p:nvSpPr>
              <p:cNvPr id="44" name="직사각형 43"/>
              <p:cNvSpPr/>
              <p:nvPr/>
            </p:nvSpPr>
            <p:spPr>
              <a:xfrm>
                <a:off x="178376" y="3261333"/>
                <a:ext cx="2591956" cy="1840311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42" name="그룹 41"/>
              <p:cNvGrpSpPr/>
              <p:nvPr/>
            </p:nvGrpSpPr>
            <p:grpSpPr>
              <a:xfrm>
                <a:off x="49964" y="3657145"/>
                <a:ext cx="2595527" cy="1332049"/>
                <a:chOff x="-204612" y="3504501"/>
                <a:chExt cx="2595527" cy="1332049"/>
              </a:xfrm>
            </p:grpSpPr>
            <p:grpSp>
              <p:nvGrpSpPr>
                <p:cNvPr id="45" name="그룹 44"/>
                <p:cNvGrpSpPr/>
                <p:nvPr/>
              </p:nvGrpSpPr>
              <p:grpSpPr>
                <a:xfrm>
                  <a:off x="-18537" y="3504501"/>
                  <a:ext cx="2409452" cy="413605"/>
                  <a:chOff x="-62987" y="3536251"/>
                  <a:chExt cx="2409452" cy="413605"/>
                </a:xfrm>
              </p:grpSpPr>
              <p:cxnSp>
                <p:nvCxnSpPr>
                  <p:cNvPr id="52" name="직선 연결선 51"/>
                  <p:cNvCxnSpPr/>
                  <p:nvPr/>
                </p:nvCxnSpPr>
                <p:spPr>
                  <a:xfrm>
                    <a:off x="613269" y="3876080"/>
                    <a:ext cx="1584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" name="직선 연결선 52"/>
                  <p:cNvCxnSpPr/>
                  <p:nvPr/>
                </p:nvCxnSpPr>
                <p:spPr>
                  <a:xfrm>
                    <a:off x="613269" y="3804080"/>
                    <a:ext cx="0" cy="144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" name="직선 연결선 53"/>
                  <p:cNvCxnSpPr/>
                  <p:nvPr/>
                </p:nvCxnSpPr>
                <p:spPr>
                  <a:xfrm>
                    <a:off x="2207818" y="3805856"/>
                    <a:ext cx="0" cy="144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5" name="TextBox 54"/>
                  <p:cNvSpPr txBox="1"/>
                  <p:nvPr/>
                </p:nvSpPr>
                <p:spPr>
                  <a:xfrm>
                    <a:off x="-62987" y="3536259"/>
                    <a:ext cx="53223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ko-KR" sz="800" dirty="0" smtClean="0">
                        <a:latin typeface="Arial" panose="020B0604020202020204" pitchFamily="34" charset="0"/>
                        <a:ea typeface="Tahoma" pitchFamily="34" charset="0"/>
                        <a:cs typeface="Arial" panose="020B0604020202020204" pitchFamily="34" charset="0"/>
                      </a:rPr>
                      <a:t>Day</a:t>
                    </a:r>
                    <a:endParaRPr lang="ko-KR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6" name="TextBox 55"/>
                  <p:cNvSpPr txBox="1"/>
                  <p:nvPr/>
                </p:nvSpPr>
                <p:spPr>
                  <a:xfrm>
                    <a:off x="2069763" y="3536251"/>
                    <a:ext cx="27670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dirty="0" smtClean="0">
                        <a:latin typeface="Arial" panose="020B0604020202020204" pitchFamily="34" charset="0"/>
                        <a:ea typeface="Tahoma" pitchFamily="34" charset="0"/>
                        <a:cs typeface="Arial" panose="020B0604020202020204" pitchFamily="34" charset="0"/>
                      </a:rPr>
                      <a:t>7</a:t>
                    </a:r>
                    <a:endParaRPr lang="ko-KR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7" name="TextBox 56"/>
                  <p:cNvSpPr txBox="1"/>
                  <p:nvPr/>
                </p:nvSpPr>
                <p:spPr>
                  <a:xfrm>
                    <a:off x="404321" y="3536259"/>
                    <a:ext cx="41789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dirty="0" smtClean="0">
                        <a:latin typeface="Arial" panose="020B0604020202020204" pitchFamily="34" charset="0"/>
                        <a:ea typeface="Tahoma" pitchFamily="34" charset="0"/>
                        <a:cs typeface="Arial" panose="020B0604020202020204" pitchFamily="34" charset="0"/>
                      </a:rPr>
                      <a:t>-1</a:t>
                    </a:r>
                    <a:endParaRPr lang="ko-KR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59" name="직선 연결선 58"/>
                  <p:cNvCxnSpPr/>
                  <p:nvPr/>
                </p:nvCxnSpPr>
                <p:spPr>
                  <a:xfrm>
                    <a:off x="799851" y="3805856"/>
                    <a:ext cx="0" cy="144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0" name="TextBox 59"/>
                  <p:cNvSpPr txBox="1"/>
                  <p:nvPr/>
                </p:nvSpPr>
                <p:spPr>
                  <a:xfrm>
                    <a:off x="590903" y="3536255"/>
                    <a:ext cx="41789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800" dirty="0" smtClean="0">
                        <a:latin typeface="Arial" panose="020B0604020202020204" pitchFamily="34" charset="0"/>
                        <a:ea typeface="Tahoma" pitchFamily="34" charset="0"/>
                        <a:cs typeface="Arial" panose="020B0604020202020204" pitchFamily="34" charset="0"/>
                      </a:rPr>
                      <a:t>0</a:t>
                    </a:r>
                    <a:endParaRPr lang="ko-KR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46" name="직선 화살표 연결선 45"/>
                <p:cNvCxnSpPr/>
                <p:nvPr/>
              </p:nvCxnSpPr>
              <p:spPr>
                <a:xfrm flipV="1">
                  <a:off x="844300" y="4023725"/>
                  <a:ext cx="0" cy="144000"/>
                </a:xfrm>
                <a:prstGeom prst="straightConnector1">
                  <a:avLst/>
                </a:prstGeom>
                <a:ln w="19050">
                  <a:solidFill>
                    <a:srgbClr val="00B050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" name="TextBox 46"/>
                <p:cNvSpPr txBox="1"/>
                <p:nvPr/>
              </p:nvSpPr>
              <p:spPr>
                <a:xfrm>
                  <a:off x="-204612" y="3980763"/>
                  <a:ext cx="94711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dirty="0" smtClean="0">
                      <a:latin typeface="Arial" panose="020B0604020202020204" pitchFamily="34" charset="0"/>
                      <a:ea typeface="Tahoma" pitchFamily="34" charset="0"/>
                      <a:cs typeface="Arial" panose="020B0604020202020204" pitchFamily="34" charset="0"/>
                    </a:rPr>
                    <a:t>UUO surgery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8" name="직선 화살표 연결선 47"/>
                <p:cNvCxnSpPr/>
                <p:nvPr/>
              </p:nvCxnSpPr>
              <p:spPr>
                <a:xfrm flipV="1">
                  <a:off x="844300" y="4347458"/>
                  <a:ext cx="0" cy="144000"/>
                </a:xfrm>
                <a:prstGeom prst="straightConnector1">
                  <a:avLst/>
                </a:prstGeom>
                <a:ln w="19050">
                  <a:solidFill>
                    <a:srgbClr val="C00000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" name="TextBox 48"/>
                <p:cNvSpPr txBox="1"/>
                <p:nvPr/>
              </p:nvSpPr>
              <p:spPr>
                <a:xfrm>
                  <a:off x="-76200" y="4177425"/>
                  <a:ext cx="861255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dirty="0" smtClean="0">
                      <a:latin typeface="Arial" panose="020B0604020202020204" pitchFamily="34" charset="0"/>
                      <a:ea typeface="Tahoma" pitchFamily="34" charset="0"/>
                      <a:cs typeface="Arial" panose="020B0604020202020204" pitchFamily="34" charset="0"/>
                    </a:rPr>
                    <a:t>Vehicle or mPTD-BMP-7</a:t>
                  </a:r>
                </a:p>
                <a:p>
                  <a:pPr algn="r"/>
                  <a:r>
                    <a:rPr lang="en-US" altLang="ko-KR" sz="800" dirty="0" smtClean="0">
                      <a:latin typeface="Arial" panose="020B0604020202020204" pitchFamily="34" charset="0"/>
                      <a:ea typeface="Tahoma" pitchFamily="34" charset="0"/>
                      <a:cs typeface="Arial" panose="020B0604020202020204" pitchFamily="34" charset="0"/>
                    </a:rPr>
                    <a:t>(20 </a:t>
                  </a:r>
                  <a:r>
                    <a:rPr lang="el-GR" altLang="ko-KR" sz="800" dirty="0" smtClean="0">
                      <a:latin typeface="Arial" panose="020B0604020202020204" pitchFamily="34" charset="0"/>
                      <a:ea typeface="Tahoma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ko-KR" sz="800" dirty="0" smtClean="0">
                      <a:latin typeface="Arial" panose="020B0604020202020204" pitchFamily="34" charset="0"/>
                      <a:ea typeface="Tahoma" pitchFamily="34" charset="0"/>
                      <a:cs typeface="Arial" panose="020B0604020202020204" pitchFamily="34" charset="0"/>
                    </a:rPr>
                    <a:t>g/mice)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107554" y="4621106"/>
                  <a:ext cx="64534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dirty="0" smtClean="0">
                      <a:latin typeface="Arial" panose="020B0604020202020204" pitchFamily="34" charset="0"/>
                      <a:ea typeface="Tahoma" pitchFamily="34" charset="0"/>
                      <a:cs typeface="Arial" panose="020B0604020202020204" pitchFamily="34" charset="0"/>
                    </a:rPr>
                    <a:t>Sacrifice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1" name="직선 화살표 연결선 50"/>
                <p:cNvCxnSpPr/>
                <p:nvPr/>
              </p:nvCxnSpPr>
              <p:spPr>
                <a:xfrm flipV="1">
                  <a:off x="2241469" y="4621106"/>
                  <a:ext cx="0" cy="144000"/>
                </a:xfrm>
                <a:prstGeom prst="straightConnector1">
                  <a:avLst/>
                </a:prstGeom>
                <a:ln w="19050">
                  <a:solidFill>
                    <a:srgbClr val="0070C0"/>
                  </a:solidFill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3" name="TextBox 42"/>
              <p:cNvSpPr txBox="1"/>
              <p:nvPr/>
            </p:nvSpPr>
            <p:spPr>
              <a:xfrm>
                <a:off x="555089" y="3313654"/>
                <a:ext cx="21515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travenous administration UUO model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61" name="직선 화살표 연결선 60"/>
            <p:cNvCxnSpPr/>
            <p:nvPr/>
          </p:nvCxnSpPr>
          <p:spPr>
            <a:xfrm flipV="1">
              <a:off x="2380318" y="6445199"/>
              <a:ext cx="0" cy="14400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직선 화살표 연결선 61"/>
            <p:cNvCxnSpPr/>
            <p:nvPr/>
          </p:nvCxnSpPr>
          <p:spPr>
            <a:xfrm flipV="1">
              <a:off x="2573366" y="6445199"/>
              <a:ext cx="0" cy="14400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직선 화살표 연결선 62"/>
            <p:cNvCxnSpPr/>
            <p:nvPr/>
          </p:nvCxnSpPr>
          <p:spPr>
            <a:xfrm flipV="1">
              <a:off x="2784876" y="6445199"/>
              <a:ext cx="0" cy="14400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직선 화살표 연결선 63"/>
            <p:cNvCxnSpPr/>
            <p:nvPr/>
          </p:nvCxnSpPr>
          <p:spPr>
            <a:xfrm flipV="1">
              <a:off x="2992296" y="6445199"/>
              <a:ext cx="0" cy="14400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직선 화살표 연결선 64"/>
            <p:cNvCxnSpPr/>
            <p:nvPr/>
          </p:nvCxnSpPr>
          <p:spPr>
            <a:xfrm flipV="1">
              <a:off x="3205691" y="6445142"/>
              <a:ext cx="0" cy="14400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직선 화살표 연결선 65"/>
            <p:cNvCxnSpPr/>
            <p:nvPr/>
          </p:nvCxnSpPr>
          <p:spPr>
            <a:xfrm flipV="1">
              <a:off x="3413176" y="6448411"/>
              <a:ext cx="0" cy="14400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9003" y="926084"/>
            <a:ext cx="1077344" cy="811177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9003" y="1774744"/>
            <a:ext cx="1082233" cy="814858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4730" y="928696"/>
            <a:ext cx="1073876" cy="808565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2613" y="1774744"/>
            <a:ext cx="1077499" cy="811293"/>
          </a:xfrm>
          <a:prstGeom prst="rect">
            <a:avLst/>
          </a:prstGeom>
        </p:spPr>
      </p:pic>
      <p:pic>
        <p:nvPicPr>
          <p:cNvPr id="40" name="그림 3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893" y="3232954"/>
            <a:ext cx="3094841" cy="1597047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0952" y="3285828"/>
            <a:ext cx="2504594" cy="1664665"/>
          </a:xfrm>
          <a:prstGeom prst="rect">
            <a:avLst/>
          </a:prstGeom>
        </p:spPr>
      </p:pic>
      <p:pic>
        <p:nvPicPr>
          <p:cNvPr id="67" name="그림 6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6989" y="1414938"/>
            <a:ext cx="1227452" cy="859435"/>
          </a:xfrm>
          <a:prstGeom prst="rect">
            <a:avLst/>
          </a:prstGeom>
        </p:spPr>
      </p:pic>
      <p:sp>
        <p:nvSpPr>
          <p:cNvPr id="68" name="TextBox 67"/>
          <p:cNvSpPr txBox="1"/>
          <p:nvPr/>
        </p:nvSpPr>
        <p:spPr>
          <a:xfrm>
            <a:off x="769" y="396283"/>
            <a:ext cx="3706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598450" y="368306"/>
            <a:ext cx="3706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2658" y="2916496"/>
            <a:ext cx="382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391434" y="697041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ea typeface="Tahoma" pitchFamily="34" charset="0"/>
                <a:cs typeface="Arial" panose="020B0604020202020204" pitchFamily="34" charset="0"/>
              </a:rPr>
              <a:t>Sham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4533912" y="710640"/>
            <a:ext cx="4122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ea typeface="Tahoma" pitchFamily="34" charset="0"/>
                <a:cs typeface="Arial" panose="020B0604020202020204" pitchFamily="34" charset="0"/>
              </a:rPr>
              <a:t>UUO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 rot="16200000">
            <a:off x="2679831" y="1224089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ea typeface="Tahoma" pitchFamily="34" charset="0"/>
                <a:cs typeface="Arial" panose="020B0604020202020204" pitchFamily="34" charset="0"/>
              </a:rPr>
              <a:t>Vehicle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 rot="16200000">
            <a:off x="2516767" y="2090379"/>
            <a:ext cx="822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ea typeface="Tahoma" pitchFamily="34" charset="0"/>
                <a:cs typeface="Arial" panose="020B0604020202020204" pitchFamily="34" charset="0"/>
              </a:rPr>
              <a:t>mPTD-BMP-7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352601" y="3205878"/>
            <a:ext cx="52290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ea typeface="Tahoma" pitchFamily="34" charset="0"/>
                <a:cs typeface="Arial" panose="020B0604020202020204" pitchFamily="34" charset="0"/>
              </a:rPr>
              <a:t>Vehicle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2180719" y="3205878"/>
            <a:ext cx="105917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ea typeface="Tahoma" pitchFamily="34" charset="0"/>
                <a:cs typeface="Arial" panose="020B0604020202020204" pitchFamily="34" charset="0"/>
              </a:rPr>
              <a:t>mPTD-BMP-7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34382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1" y="0"/>
            <a:ext cx="67558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 2. 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그룹 4"/>
          <p:cNvGrpSpPr/>
          <p:nvPr/>
        </p:nvGrpSpPr>
        <p:grpSpPr>
          <a:xfrm>
            <a:off x="368067" y="4409615"/>
            <a:ext cx="4746144" cy="3754187"/>
            <a:chOff x="368067" y="4409615"/>
            <a:chExt cx="4746144" cy="3754187"/>
          </a:xfrm>
        </p:grpSpPr>
        <p:pic>
          <p:nvPicPr>
            <p:cNvPr id="30" name="그림 29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4316" y="4409615"/>
              <a:ext cx="2215621" cy="1737742"/>
            </a:xfrm>
            <a:prstGeom prst="rect">
              <a:avLst/>
            </a:prstGeom>
          </p:spPr>
        </p:pic>
        <p:pic>
          <p:nvPicPr>
            <p:cNvPr id="31" name="그림 3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4316" y="6210616"/>
              <a:ext cx="2215621" cy="1737742"/>
            </a:xfrm>
            <a:prstGeom prst="rect">
              <a:avLst/>
            </a:prstGeom>
          </p:spPr>
        </p:pic>
        <p:pic>
          <p:nvPicPr>
            <p:cNvPr id="32" name="그림 3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98590" y="6210616"/>
              <a:ext cx="2215620" cy="1737742"/>
            </a:xfrm>
            <a:prstGeom prst="rect">
              <a:avLst/>
            </a:prstGeom>
          </p:spPr>
        </p:pic>
        <p:pic>
          <p:nvPicPr>
            <p:cNvPr id="33" name="그림 3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98590" y="4409615"/>
              <a:ext cx="2215621" cy="1737742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 rot="16200000">
              <a:off x="64458" y="7039687"/>
              <a:ext cx="8226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PTD-BMP-7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564032" y="7948358"/>
              <a:ext cx="3561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H/E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451600" y="7948358"/>
              <a:ext cx="110959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Masson’s Trichrome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216490" y="5092119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30410" y="727336"/>
            <a:ext cx="3706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0410" y="3936113"/>
            <a:ext cx="3706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215014" y="935967"/>
            <a:ext cx="4678993" cy="2459815"/>
            <a:chOff x="484094" y="834503"/>
            <a:chExt cx="4678993" cy="2459815"/>
          </a:xfrm>
        </p:grpSpPr>
        <p:pic>
          <p:nvPicPr>
            <p:cNvPr id="11" name="내용 개체 틀 3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49936" y="1205191"/>
              <a:ext cx="2313151" cy="1814236"/>
            </a:xfrm>
            <a:prstGeom prst="rect">
              <a:avLst/>
            </a:prstGeom>
          </p:spPr>
        </p:pic>
        <p:pic>
          <p:nvPicPr>
            <p:cNvPr id="12" name="내용 개체 틀 3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4094" y="1205190"/>
              <a:ext cx="2313150" cy="1814236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2512783" y="834503"/>
              <a:ext cx="6783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ab84684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408157" y="3019426"/>
              <a:ext cx="603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570178" y="3048097"/>
              <a:ext cx="9829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PTD-BMP-7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" name="직선 연결선 3"/>
            <p:cNvCxnSpPr/>
            <p:nvPr/>
          </p:nvCxnSpPr>
          <p:spPr>
            <a:xfrm>
              <a:off x="613254" y="1091969"/>
              <a:ext cx="44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타원 21"/>
            <p:cNvSpPr/>
            <p:nvPr/>
          </p:nvSpPr>
          <p:spPr>
            <a:xfrm>
              <a:off x="4219957" y="2064626"/>
              <a:ext cx="851748" cy="429289"/>
            </a:xfrm>
            <a:prstGeom prst="ellipse">
              <a:avLst/>
            </a:prstGeom>
            <a:noFill/>
            <a:ln w="28575">
              <a:solidFill>
                <a:srgbClr val="C0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3" name="타원 22"/>
            <p:cNvSpPr/>
            <p:nvPr/>
          </p:nvSpPr>
          <p:spPr>
            <a:xfrm>
              <a:off x="3494550" y="1428363"/>
              <a:ext cx="725407" cy="429289"/>
            </a:xfrm>
            <a:prstGeom prst="ellipse">
              <a:avLst/>
            </a:prstGeom>
            <a:noFill/>
            <a:ln w="28575">
              <a:solidFill>
                <a:srgbClr val="C0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24" name="그룹 23"/>
          <p:cNvGrpSpPr/>
          <p:nvPr/>
        </p:nvGrpSpPr>
        <p:grpSpPr>
          <a:xfrm>
            <a:off x="5145916" y="1087721"/>
            <a:ext cx="1468938" cy="1666220"/>
            <a:chOff x="2348389" y="2067730"/>
            <a:chExt cx="1468938" cy="1666220"/>
          </a:xfrm>
        </p:grpSpPr>
        <p:pic>
          <p:nvPicPr>
            <p:cNvPr id="25" name="그림 24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20146" y="2891215"/>
              <a:ext cx="593124" cy="371864"/>
            </a:xfrm>
            <a:prstGeom prst="rect">
              <a:avLst/>
            </a:prstGeom>
          </p:spPr>
        </p:pic>
        <p:pic>
          <p:nvPicPr>
            <p:cNvPr id="26" name="그림 25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21808" y="3322374"/>
              <a:ext cx="589799" cy="350298"/>
            </a:xfrm>
            <a:prstGeom prst="rect">
              <a:avLst/>
            </a:prstGeom>
          </p:spPr>
        </p:pic>
        <p:sp>
          <p:nvSpPr>
            <p:cNvPr id="27" name="TextBox 26"/>
            <p:cNvSpPr txBox="1"/>
            <p:nvPr/>
          </p:nvSpPr>
          <p:spPr>
            <a:xfrm rot="16200000">
              <a:off x="2539984" y="2529144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2652629" y="2376950"/>
              <a:ext cx="8338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PTD-BMP-7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357072" y="310769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351283" y="283979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직선 연결선 34"/>
            <p:cNvCxnSpPr/>
            <p:nvPr/>
          </p:nvCxnSpPr>
          <p:spPr>
            <a:xfrm flipV="1">
              <a:off x="2583588" y="3222939"/>
              <a:ext cx="36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/>
            <p:cNvCxnSpPr/>
            <p:nvPr/>
          </p:nvCxnSpPr>
          <p:spPr>
            <a:xfrm flipV="1">
              <a:off x="2571390" y="2937452"/>
              <a:ext cx="36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2359202" y="351850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348389" y="323051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직선 연결선 38"/>
            <p:cNvCxnSpPr/>
            <p:nvPr/>
          </p:nvCxnSpPr>
          <p:spPr>
            <a:xfrm flipV="1">
              <a:off x="2585718" y="3633755"/>
              <a:ext cx="36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직선 연결선 39"/>
            <p:cNvCxnSpPr/>
            <p:nvPr/>
          </p:nvCxnSpPr>
          <p:spPr>
            <a:xfrm flipV="1">
              <a:off x="2573520" y="3348268"/>
              <a:ext cx="3600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3220413" y="2937452"/>
              <a:ext cx="5661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l-GR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A</a:t>
              </a:r>
            </a:p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MP-7)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223895" y="3389801"/>
              <a:ext cx="5934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onceau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4" name="TextBox 43"/>
          <p:cNvSpPr txBox="1"/>
          <p:nvPr/>
        </p:nvSpPr>
        <p:spPr>
          <a:xfrm>
            <a:off x="4967246" y="742335"/>
            <a:ext cx="3706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78652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330287"/>
          </a:xfrm>
        </p:spPr>
        <p:txBody>
          <a:bodyPr>
            <a:norm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qPCR primer list and sequences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" y="0"/>
            <a:ext cx="67558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Data 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1468926"/>
              </p:ext>
            </p:extLst>
          </p:nvPr>
        </p:nvGraphicFramePr>
        <p:xfrm>
          <a:off x="360250" y="977661"/>
          <a:ext cx="4998229" cy="239300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10729">
                  <a:extLst>
                    <a:ext uri="{9D8B030D-6E8A-4147-A177-3AD203B41FA5}">
                      <a16:colId xmlns:a16="http://schemas.microsoft.com/office/drawing/2014/main" val="2388811098"/>
                    </a:ext>
                  </a:extLst>
                </a:gridCol>
                <a:gridCol w="807914">
                  <a:extLst>
                    <a:ext uri="{9D8B030D-6E8A-4147-A177-3AD203B41FA5}">
                      <a16:colId xmlns:a16="http://schemas.microsoft.com/office/drawing/2014/main" val="1780774560"/>
                    </a:ext>
                  </a:extLst>
                </a:gridCol>
                <a:gridCol w="3079586">
                  <a:extLst>
                    <a:ext uri="{9D8B030D-6E8A-4147-A177-3AD203B41FA5}">
                      <a16:colId xmlns:a16="http://schemas.microsoft.com/office/drawing/2014/main" val="279997995"/>
                    </a:ext>
                  </a:extLst>
                </a:gridCol>
              </a:tblGrid>
              <a:tr h="284385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s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extLst>
                  <a:ext uri="{0D108BD9-81ED-4DB2-BD59-A6C34878D82A}">
                    <a16:rowId xmlns:a16="http://schemas.microsoft.com/office/drawing/2014/main" val="1779141872"/>
                  </a:ext>
                </a:extLst>
              </a:tr>
              <a:tr h="83820">
                <a:tc rowSpan="2"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ko-KR" sz="1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hPAI-1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ko-KR" sz="1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orward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ko-KR" altLang="ko-KR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r>
                        <a:rPr lang="en-US" altLang="ko-KR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altLang="ko-KR" sz="11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ttcaggctgacttcacgag</a:t>
                      </a:r>
                      <a:endParaRPr lang="ko-KR" altLang="ko-KR" sz="1200" dirty="0" smtClean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extLst>
                  <a:ext uri="{0D108BD9-81ED-4DB2-BD59-A6C34878D82A}">
                    <a16:rowId xmlns:a16="http://schemas.microsoft.com/office/drawing/2014/main" val="113425705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everse</a:t>
                      </a:r>
                      <a:endParaRPr lang="ko-KR" altLang="ko-KR" sz="1100" dirty="0" smtClean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ko-KR" altLang="ko-KR" sz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r>
                        <a:rPr lang="en-US" altLang="ko-KR" sz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altLang="ko-KR" sz="12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acagctgtggatgaggag</a:t>
                      </a:r>
                      <a:endParaRPr lang="ko-KR" altLang="ko-KR" sz="1400" dirty="0" smtClean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extLst>
                  <a:ext uri="{0D108BD9-81ED-4DB2-BD59-A6C34878D82A}">
                    <a16:rowId xmlns:a16="http://schemas.microsoft.com/office/drawing/2014/main" val="2091645304"/>
                  </a:ext>
                </a:extLst>
              </a:tr>
              <a:tr h="83820">
                <a:tc rowSpan="2"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ko-KR" sz="1100" dirty="0" err="1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hGAPDH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ko-KR" sz="1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Forward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atgggtgtgaacccatgagaag</a:t>
                      </a:r>
                      <a:endParaRPr lang="ko-KR" altLang="ko-KR" sz="1200" dirty="0" smtClean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extLst>
                  <a:ext uri="{0D108BD9-81ED-4DB2-BD59-A6C34878D82A}">
                    <a16:rowId xmlns:a16="http://schemas.microsoft.com/office/drawing/2014/main" val="182905016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ko-KR" sz="1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Reverse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 smtClean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’-agttgtcatggatgaccttgg</a:t>
                      </a:r>
                      <a:endParaRPr lang="ko-KR" altLang="ko-KR" sz="1200" dirty="0" smtClean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extLst>
                  <a:ext uri="{0D108BD9-81ED-4DB2-BD59-A6C34878D82A}">
                    <a16:rowId xmlns:a16="http://schemas.microsoft.com/office/drawing/2014/main" val="1655613316"/>
                  </a:ext>
                </a:extLst>
              </a:tr>
              <a:tr h="174042">
                <a:tc rowSpan="2"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Fibronectin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ko-KR" sz="1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GACAACTGCCGTAGACCTGG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extLst>
                  <a:ext uri="{0D108BD9-81ED-4DB2-BD59-A6C34878D82A}">
                    <a16:rowId xmlns:a16="http://schemas.microsoft.com/office/drawing/2014/main" val="2568490884"/>
                  </a:ext>
                </a:extLst>
              </a:tr>
              <a:tr h="1740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ko-KR" sz="1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ACTGGTTGTAGGTGTGGCCG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extLst>
                  <a:ext uri="{0D108BD9-81ED-4DB2-BD59-A6C34878D82A}">
                    <a16:rowId xmlns:a16="http://schemas.microsoft.com/office/drawing/2014/main" val="3447133661"/>
                  </a:ext>
                </a:extLst>
              </a:tr>
              <a:tr h="174042">
                <a:tc rowSpan="2"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ol</a:t>
                      </a: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I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ko-KR" sz="1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AGCGGAGAGTACTGGATCG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extLst>
                  <a:ext uri="{0D108BD9-81ED-4DB2-BD59-A6C34878D82A}">
                    <a16:rowId xmlns:a16="http://schemas.microsoft.com/office/drawing/2014/main" val="2252485399"/>
                  </a:ext>
                </a:extLst>
              </a:tr>
              <a:tr h="1740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ko-KR" sz="1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CTTCTTTTCCTTGGGGTTC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extLst>
                  <a:ext uri="{0D108BD9-81ED-4DB2-BD59-A6C34878D82A}">
                    <a16:rowId xmlns:a16="http://schemas.microsoft.com/office/drawing/2014/main" val="100766331"/>
                  </a:ext>
                </a:extLst>
              </a:tr>
              <a:tr h="174042">
                <a:tc rowSpan="2"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α-SMA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ko-KR" sz="1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TGACAGAGGCACCACTGAA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extLst>
                  <a:ext uri="{0D108BD9-81ED-4DB2-BD59-A6C34878D82A}">
                    <a16:rowId xmlns:a16="http://schemas.microsoft.com/office/drawing/2014/main" val="3005482511"/>
                  </a:ext>
                </a:extLst>
              </a:tr>
              <a:tr h="1740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ko-KR" sz="1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ATCTCCAGAGTCCAGCACA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extLst>
                  <a:ext uri="{0D108BD9-81ED-4DB2-BD59-A6C34878D82A}">
                    <a16:rowId xmlns:a16="http://schemas.microsoft.com/office/drawing/2014/main" val="3453052205"/>
                  </a:ext>
                </a:extLst>
              </a:tr>
              <a:tr h="174042">
                <a:tc rowSpan="2"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8s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ko-KR" sz="1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GCTTCCTTACCTGGTTGAT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extLst>
                  <a:ext uri="{0D108BD9-81ED-4DB2-BD59-A6C34878D82A}">
                    <a16:rowId xmlns:a16="http://schemas.microsoft.com/office/drawing/2014/main" val="400345601"/>
                  </a:ext>
                </a:extLst>
              </a:tr>
              <a:tr h="1740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ko-KR" sz="1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GCCGTGCGTACTTAGACAT</a:t>
                      </a:r>
                      <a:endParaRPr lang="ko-KR" sz="1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5266" marR="65266" marT="0" marB="0" anchor="ctr"/>
                </a:tc>
                <a:extLst>
                  <a:ext uri="{0D108BD9-81ED-4DB2-BD59-A6C34878D82A}">
                    <a16:rowId xmlns:a16="http://schemas.microsoft.com/office/drawing/2014/main" val="162864164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21146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04</TotalTime>
  <Words>126</Words>
  <Application>Microsoft Office PowerPoint</Application>
  <PresentationFormat>Letter 용지(8.5x11in)</PresentationFormat>
  <Paragraphs>73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Tahoma</vt:lpstr>
      <vt:lpstr>Office 테마</vt:lpstr>
      <vt:lpstr>PowerPoint 프레젠테이션</vt:lpstr>
      <vt:lpstr>PowerPoint 프레젠테이션</vt:lpstr>
      <vt:lpstr>qPCR primer list and sequ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유태현(내과학교실)</dc:creator>
  <cp:lastModifiedBy>Jong In Yook</cp:lastModifiedBy>
  <cp:revision>102</cp:revision>
  <dcterms:created xsi:type="dcterms:W3CDTF">2020-03-30T22:47:22Z</dcterms:created>
  <dcterms:modified xsi:type="dcterms:W3CDTF">2020-09-22T03:43:52Z</dcterms:modified>
</cp:coreProperties>
</file>